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  <p:sldId id="257" r:id="rId3"/>
    <p:sldId id="258" r:id="rId4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napToGrid="0">
      <p:cViewPr>
        <p:scale>
          <a:sx n="70" d="100"/>
          <a:sy n="70" d="100"/>
        </p:scale>
        <p:origin x="1680" y="-3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9123;&#30707;&#21307;&#23398;\&#20250;&#35758;&#25237;&#31295;\2022WCLC\EGFR%20&#32467;&#26500;&#20998;&#22411;&#25991;&#31456;2022.10.22%20v2\Figures_20221130\Figures_20221130\Fig2\Distribut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9123;&#30707;&#21307;&#23398;\&#20250;&#35758;&#25237;&#31295;\2022WCLC\EGFR%20&#32467;&#26500;&#20998;&#22411;&#25991;&#31456;2022.10.22%20v2\Figures_20221130\Figures_20221201\Figures_20221201\Fig2\Fig2B_atypical_count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9123;&#30707;&#21307;&#23398;-2022-12\&#20250;&#35758;&#25237;&#31295;\2022WCLC\EGFR%20&#32467;&#26500;&#20998;&#22411;&#25991;&#31456;2022.10.22%20v2\Figures_20221130\Figures_20221201\Figures_20221201\Fig2\Fig2B_atypical_count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29123;&#30707;&#21307;&#23398;-2022-12\&#20250;&#35758;&#25237;&#31295;\2022WCLC\EGFR%20&#32467;&#26500;&#20998;&#22411;&#25991;&#31456;2022.10.22%20v2\Figures_20221130\Figures_20221201\Figures_20221201\Fig2\Fig2B_atypical_count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ofPieChart>
        <c:ofPieType val="bar"/>
        <c:varyColors val="1"/>
        <c:dLbls>
          <c:dLblPos val="bestFit"/>
          <c:showLegendKey val="0"/>
          <c:showVal val="0"/>
          <c:showCatName val="1"/>
          <c:showSerName val="0"/>
          <c:showPercent val="1"/>
          <c:showBubbleSize val="0"/>
          <c:showLeaderLines val="0"/>
        </c:dLbls>
        <c:gapWidth val="100"/>
        <c:splitType val="pos"/>
        <c:splitPos val="4"/>
        <c:secondPieSize val="100"/>
        <c:serLines>
          <c:spPr>
            <a:ln w="9525" cap="flat" cmpd="sng" algn="ctr">
              <a:solidFill>
                <a:schemeClr val="tx1">
                  <a:lumMod val="35000"/>
                  <a:lumOff val="65000"/>
                </a:schemeClr>
              </a:solidFill>
              <a:round/>
            </a:ln>
            <a:effectLst/>
          </c:spPr>
        </c:serLines>
      </c:of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ofPieChart>
        <c:ofPieType val="pie"/>
        <c:varyColors val="1"/>
        <c:dLbls>
          <c:dLblPos val="bestFit"/>
          <c:showLegendKey val="0"/>
          <c:showVal val="1"/>
          <c:showCatName val="1"/>
          <c:showSerName val="0"/>
          <c:showPercent val="0"/>
          <c:showBubbleSize val="0"/>
          <c:showLeaderLines val="0"/>
        </c:dLbls>
        <c:gapWidth val="100"/>
        <c:splitType val="pos"/>
        <c:splitPos val="9"/>
        <c:secondPieSize val="100"/>
        <c:serLines>
          <c:spPr>
            <a:ln w="9525" cap="flat" cmpd="sng" algn="ctr">
              <a:solidFill>
                <a:schemeClr val="tx1">
                  <a:lumMod val="35000"/>
                  <a:lumOff val="65000"/>
                </a:schemeClr>
              </a:solidFill>
              <a:round/>
            </a:ln>
            <a:effectLst/>
          </c:spPr>
        </c:serLines>
      </c:of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214908156612062"/>
          <c:y val="6.2937062937062943E-2"/>
          <c:w val="0.82750970717674988"/>
          <c:h val="0.79807719839215907"/>
        </c:manualLayout>
      </c:layout>
      <c:ofPieChart>
        <c:ofPieType val="pie"/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F1D-41E3-8EA5-A586CAC614C4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F1D-41E3-8EA5-A586CAC614C4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F1D-41E3-8EA5-A586CAC614C4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6F1D-41E3-8EA5-A586CAC614C4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6F1D-41E3-8EA5-A586CAC614C4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6F1D-41E3-8EA5-A586CAC614C4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6F1D-41E3-8EA5-A586CAC614C4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6F1D-41E3-8EA5-A586CAC614C4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6F1D-41E3-8EA5-A586CAC614C4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6F1D-41E3-8EA5-A586CAC614C4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6F1D-41E3-8EA5-A586CAC614C4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6F1D-41E3-8EA5-A586CAC614C4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6F1D-41E3-8EA5-A586CAC614C4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6F1D-41E3-8EA5-A586CAC614C4}"/>
              </c:ext>
            </c:extLst>
          </c:dPt>
          <c:dLbls>
            <c:dLbl>
              <c:idx val="1"/>
              <c:layout>
                <c:manualLayout>
                  <c:x val="0.10819992126835455"/>
                  <c:y val="0.13474120367821155"/>
                </c:manualLayout>
              </c:layout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3-6F1D-41E3-8EA5-A586CAC614C4}"/>
                </c:ext>
              </c:extLst>
            </c:dLbl>
            <c:dLbl>
              <c:idx val="2"/>
              <c:layout>
                <c:manualLayout>
                  <c:x val="-5.8203966633555863E-2"/>
                  <c:y val="-8.0966081162931566E-2"/>
                </c:manualLayout>
              </c:layout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6F1D-41E3-8EA5-A586CAC614C4}"/>
                </c:ext>
              </c:extLst>
            </c:dLbl>
            <c:dLbl>
              <c:idx val="3"/>
              <c:layout>
                <c:manualLayout>
                  <c:x val="-6.8563523996838715E-3"/>
                  <c:y val="-1.4516269106067623E-2"/>
                </c:manualLayout>
              </c:layout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6F1D-41E3-8EA5-A586CAC614C4}"/>
                </c:ext>
              </c:extLst>
            </c:dLbl>
            <c:dLbl>
              <c:idx val="4"/>
              <c:layout>
                <c:manualLayout>
                  <c:x val="-2.2996711356054009E-2"/>
                  <c:y val="-0.10155332856120258"/>
                </c:manualLayout>
              </c:layout>
              <c:tx>
                <c:rich>
                  <a:bodyPr/>
                  <a:lstStyle/>
                  <a:p>
                    <a:fld id="{D5D354FA-B3E3-4AA1-A94B-1E4C194310FB}" type="CATEGORYNAME">
                      <a:rPr lang="en-US" altLang="zh-CN"/>
                      <a:pPr/>
                      <a:t>[类别名称]</a:t>
                    </a:fld>
                    <a:r>
                      <a:rPr lang="en-US" altLang="zh-CN" baseline="0"/>
                      <a:t>, </a:t>
                    </a:r>
                    <a:fld id="{C60DE977-8FF1-49E9-B711-45CB0C10F97E}" type="VALUE">
                      <a:rPr lang="en-US" altLang="zh-CN" baseline="0"/>
                      <a:pPr/>
                      <a:t>[值]</a:t>
                    </a:fld>
                    <a:r>
                      <a:rPr lang="en-US" altLang="zh-CN" baseline="0"/>
                      <a:t>, 21.5%</a:t>
                    </a:r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9-6F1D-41E3-8EA5-A586CAC614C4}"/>
                </c:ext>
              </c:extLst>
            </c:dLbl>
            <c:dLbl>
              <c:idx val="5"/>
              <c:layout>
                <c:manualLayout>
                  <c:x val="0.14493880620253069"/>
                  <c:y val="-6.6113650129398155E-2"/>
                </c:manualLayout>
              </c:layout>
              <c:tx>
                <c:rich>
                  <a:bodyPr/>
                  <a:lstStyle/>
                  <a:p>
                    <a:fld id="{4F4D081F-0066-47FB-B20A-96EE1BF5D3AB}" type="CATEGORYNAME">
                      <a:rPr lang="en-US" altLang="zh-CN"/>
                      <a:pPr/>
                      <a:t>[类别名称]</a:t>
                    </a:fld>
                    <a:r>
                      <a:rPr lang="en-US" altLang="zh-CN" baseline="0"/>
                      <a:t>, </a:t>
                    </a:r>
                    <a:fld id="{4A21D754-5C36-4D91-BF60-86A33D814ACA}" type="VALUE">
                      <a:rPr lang="en-US" altLang="zh-CN" baseline="0"/>
                      <a:pPr/>
                      <a:t>[值]</a:t>
                    </a:fld>
                    <a:r>
                      <a:rPr lang="en-US" altLang="zh-CN" baseline="0"/>
                      <a:t>, 20.6%</a:t>
                    </a:r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B-6F1D-41E3-8EA5-A586CAC614C4}"/>
                </c:ext>
              </c:extLst>
            </c:dLbl>
            <c:dLbl>
              <c:idx val="6"/>
              <c:layout/>
              <c:tx>
                <c:rich>
                  <a:bodyPr/>
                  <a:lstStyle/>
                  <a:p>
                    <a:fld id="{7E25653E-FD59-43B8-B7AF-7250CD30177B}" type="CATEGORYNAME">
                      <a:rPr lang="en-US" altLang="zh-CN"/>
                      <a:pPr/>
                      <a:t>[类别名称]</a:t>
                    </a:fld>
                    <a:r>
                      <a:rPr lang="en-US" altLang="zh-CN" baseline="0"/>
                      <a:t>, </a:t>
                    </a:r>
                    <a:fld id="{F9CF2CD1-F2C6-4282-B34A-A0C55E5F3B73}" type="VALUE">
                      <a:rPr lang="en-US" altLang="zh-CN" baseline="0"/>
                      <a:pPr/>
                      <a:t>[值]</a:t>
                    </a:fld>
                    <a:r>
                      <a:rPr lang="en-US" altLang="zh-CN" baseline="0"/>
                      <a:t>, 13.1%</a:t>
                    </a:r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D-6F1D-41E3-8EA5-A586CAC614C4}"/>
                </c:ext>
              </c:extLst>
            </c:dLbl>
            <c:dLbl>
              <c:idx val="7"/>
              <c:layout/>
              <c:tx>
                <c:rich>
                  <a:bodyPr/>
                  <a:lstStyle/>
                  <a:p>
                    <a:fld id="{2B939524-7A09-494E-85BE-E948859BAE95}" type="CATEGORYNAME">
                      <a:rPr lang="en-US" altLang="zh-CN"/>
                      <a:pPr/>
                      <a:t>[类别名称]</a:t>
                    </a:fld>
                    <a:r>
                      <a:rPr lang="en-US" altLang="zh-CN" baseline="0"/>
                      <a:t>, </a:t>
                    </a:r>
                    <a:fld id="{FC2F9E65-3238-4184-B243-B969BE15556D}" type="VALUE">
                      <a:rPr lang="en-US" altLang="zh-CN" baseline="0"/>
                      <a:pPr/>
                      <a:t>[值]</a:t>
                    </a:fld>
                    <a:r>
                      <a:rPr lang="en-US" altLang="zh-CN" baseline="0"/>
                      <a:t>, 2.8%</a:t>
                    </a:r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F-6F1D-41E3-8EA5-A586CAC614C4}"/>
                </c:ext>
              </c:extLst>
            </c:dLbl>
            <c:dLbl>
              <c:idx val="8"/>
              <c:layout>
                <c:manualLayout>
                  <c:x val="2.0232095179624415E-2"/>
                  <c:y val="1.2132867132867133E-2"/>
                </c:manualLayout>
              </c:layout>
              <c:tx>
                <c:rich>
                  <a:bodyPr/>
                  <a:lstStyle/>
                  <a:p>
                    <a:fld id="{8AB03B7A-04FA-4AAC-98D0-47FDF0470D70}" type="CATEGORYNAME">
                      <a:rPr lang="en-US" altLang="zh-CN"/>
                      <a:pPr/>
                      <a:t>[类别名称]</a:t>
                    </a:fld>
                    <a:r>
                      <a:rPr lang="en-US" altLang="zh-CN" baseline="0"/>
                      <a:t>, </a:t>
                    </a:r>
                    <a:fld id="{21BD3E2A-DD10-4D64-8AEE-C6820E546AED}" type="VALUE">
                      <a:rPr lang="en-US" altLang="zh-CN" baseline="0"/>
                      <a:pPr/>
                      <a:t>[值]</a:t>
                    </a:fld>
                    <a:r>
                      <a:rPr lang="en-US" altLang="zh-CN" baseline="0"/>
                      <a:t>, 8.4%</a:t>
                    </a:r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1-6F1D-41E3-8EA5-A586CAC614C4}"/>
                </c:ext>
              </c:extLst>
            </c:dLbl>
            <c:dLbl>
              <c:idx val="9"/>
              <c:layout>
                <c:manualLayout>
                  <c:x val="5.6230066377983966E-2"/>
                  <c:y val="-3.3329937778756674E-2"/>
                </c:manualLayout>
              </c:layout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3-6F1D-41E3-8EA5-A586CAC614C4}"/>
                </c:ext>
              </c:extLst>
            </c:dLbl>
            <c:dLbl>
              <c:idx val="10"/>
              <c:layout>
                <c:manualLayout>
                  <c:x val="-6.4331505100219677E-3"/>
                  <c:y val="0.10635317438467044"/>
                </c:manualLayout>
              </c:layout>
              <c:tx>
                <c:rich>
                  <a:bodyPr/>
                  <a:lstStyle/>
                  <a:p>
                    <a:fld id="{BE8A47CA-136A-4277-AA1B-C605906DD84D}" type="CATEGORYNAME">
                      <a:rPr lang="en-US" altLang="zh-CN"/>
                      <a:pPr/>
                      <a:t>[类别名称]</a:t>
                    </a:fld>
                    <a:r>
                      <a:rPr lang="en-US" altLang="zh-CN" baseline="0"/>
                      <a:t>, </a:t>
                    </a:r>
                    <a:fld id="{787B7D3A-1574-42E8-91FB-1D3A50E44C98}" type="VALUE">
                      <a:rPr lang="en-US" altLang="zh-CN" baseline="0"/>
                      <a:pPr/>
                      <a:t>[值]</a:t>
                    </a:fld>
                    <a:r>
                      <a:rPr lang="en-US" altLang="zh-CN" baseline="0"/>
                      <a:t>, 19.6%</a:t>
                    </a:r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5-6F1D-41E3-8EA5-A586CAC614C4}"/>
                </c:ext>
              </c:extLst>
            </c:dLbl>
            <c:dLbl>
              <c:idx val="11"/>
              <c:layout>
                <c:manualLayout>
                  <c:x val="-1.0833589993058289E-2"/>
                  <c:y val="-4.6614999174054227E-2"/>
                </c:manualLayout>
              </c:layout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7-6F1D-41E3-8EA5-A586CAC614C4}"/>
                </c:ext>
              </c:extLst>
            </c:dLbl>
            <c:dLbl>
              <c:idx val="12"/>
              <c:layout/>
              <c:tx>
                <c:rich>
                  <a:bodyPr/>
                  <a:lstStyle/>
                  <a:p>
                    <a:r>
                      <a:rPr lang="en-US" altLang="zh-CN" baseline="0"/>
                      <a:t>Compound atypical, </a:t>
                    </a:r>
                    <a:fld id="{9556D139-A7C6-488E-9DF8-85E995761D39}" type="VALUE">
                      <a:rPr lang="en-US" altLang="zh-CN" baseline="0"/>
                      <a:pPr/>
                      <a:t>[值]</a:t>
                    </a:fld>
                    <a:r>
                      <a:rPr lang="en-US" altLang="zh-CN" baseline="0"/>
                      <a:t>, 14.0%</a:t>
                    </a:r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9-6F1D-41E3-8EA5-A586CAC614C4}"/>
                </c:ext>
              </c:extLst>
            </c:dLbl>
            <c:dLbl>
              <c:idx val="13"/>
              <c:layout/>
              <c:tx>
                <c:rich>
                  <a:bodyPr/>
                  <a:lstStyle/>
                  <a:p>
                    <a:r>
                      <a:rPr lang="en-US" altLang="zh-CN" baseline="0"/>
                      <a:t>Atypical, </a:t>
                    </a:r>
                    <a:fld id="{477C33FE-8227-48E9-B828-C5B0391C5896}" type="VALUE">
                      <a:rPr lang="en-US" altLang="zh-CN" baseline="0"/>
                      <a:pPr/>
                      <a:t>[值]</a:t>
                    </a:fld>
                    <a:r>
                      <a:rPr lang="en-US" altLang="zh-CN" baseline="0"/>
                      <a:t>, </a:t>
                    </a:r>
                    <a:fld id="{4CEE78E9-6533-405B-AD6F-A98C1CBC826D}" type="PERCENTAGE">
                      <a:rPr lang="en-US" altLang="zh-CN" baseline="0"/>
                      <a:pPr/>
                      <a:t>[百分比]</a:t>
                    </a:fld>
                    <a:endParaRPr lang="en-US" altLang="zh-CN" baseline="0"/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B-6F1D-41E3-8EA5-A586CAC614C4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CN"/>
              </a:p>
            </c:txPr>
            <c:dLblPos val="bestFit"/>
            <c:showLegendKey val="0"/>
            <c:showVal val="1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'1ST'!$A$2:$A$14</c:f>
              <c:strCache>
                <c:ptCount val="13"/>
                <c:pt idx="0">
                  <c:v>Ex19del</c:v>
                </c:pt>
                <c:pt idx="1">
                  <c:v>L858R</c:v>
                </c:pt>
                <c:pt idx="2">
                  <c:v>Ex19del/L858R+T790M</c:v>
                </c:pt>
                <c:pt idx="3">
                  <c:v>T790M</c:v>
                </c:pt>
                <c:pt idx="4">
                  <c:v>Ex20ins</c:v>
                </c:pt>
                <c:pt idx="5">
                  <c:v>L861Q</c:v>
                </c:pt>
                <c:pt idx="6">
                  <c:v>G719X</c:v>
                </c:pt>
                <c:pt idx="7">
                  <c:v>S768X</c:v>
                </c:pt>
                <c:pt idx="8">
                  <c:v>Other single atypical mutation</c:v>
                </c:pt>
                <c:pt idx="9">
                  <c:v>Ex19del/L858R+T790M+atypical </c:v>
                </c:pt>
                <c:pt idx="10">
                  <c:v>Ex19del/L858R+atypical </c:v>
                </c:pt>
                <c:pt idx="11">
                  <c:v>T790M+atypical </c:v>
                </c:pt>
                <c:pt idx="12">
                  <c:v>Compound atypical</c:v>
                </c:pt>
              </c:strCache>
            </c:strRef>
          </c:cat>
          <c:val>
            <c:numRef>
              <c:f>'1ST'!$B$2:$B$14</c:f>
              <c:numCache>
                <c:formatCode>General</c:formatCode>
                <c:ptCount val="13"/>
                <c:pt idx="0">
                  <c:v>167</c:v>
                </c:pt>
                <c:pt idx="1">
                  <c:v>149</c:v>
                </c:pt>
                <c:pt idx="2">
                  <c:v>6</c:v>
                </c:pt>
                <c:pt idx="4">
                  <c:v>23</c:v>
                </c:pt>
                <c:pt idx="5">
                  <c:v>22</c:v>
                </c:pt>
                <c:pt idx="6">
                  <c:v>14</c:v>
                </c:pt>
                <c:pt idx="7">
                  <c:v>3</c:v>
                </c:pt>
                <c:pt idx="8">
                  <c:v>9</c:v>
                </c:pt>
                <c:pt idx="10">
                  <c:v>21</c:v>
                </c:pt>
                <c:pt idx="12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C-6F1D-41E3-8EA5-A586CAC614C4}"/>
            </c:ext>
          </c:extLst>
        </c:ser>
        <c:dLbls>
          <c:dLblPos val="bestFit"/>
          <c:showLegendKey val="0"/>
          <c:showVal val="1"/>
          <c:showCatName val="1"/>
          <c:showSerName val="0"/>
          <c:showPercent val="0"/>
          <c:showBubbleSize val="0"/>
          <c:showLeaderLines val="1"/>
        </c:dLbls>
        <c:gapWidth val="100"/>
        <c:splitType val="pos"/>
        <c:splitPos val="9"/>
        <c:secondPieSize val="100"/>
        <c:serLines>
          <c:spPr>
            <a:ln w="9525" cap="flat" cmpd="sng" algn="ctr">
              <a:solidFill>
                <a:schemeClr val="tx1">
                  <a:lumMod val="35000"/>
                  <a:lumOff val="65000"/>
                </a:schemeClr>
              </a:solidFill>
              <a:round/>
            </a:ln>
            <a:effectLst/>
          </c:spPr>
        </c:serLines>
      </c:of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ofPieChart>
        <c:ofPieType val="pie"/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5E8-4DF5-9E3A-4B43671A1560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5E8-4DF5-9E3A-4B43671A1560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35E8-4DF5-9E3A-4B43671A1560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35E8-4DF5-9E3A-4B43671A1560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35E8-4DF5-9E3A-4B43671A1560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35E8-4DF5-9E3A-4B43671A1560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35E8-4DF5-9E3A-4B43671A1560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35E8-4DF5-9E3A-4B43671A1560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35E8-4DF5-9E3A-4B43671A1560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35E8-4DF5-9E3A-4B43671A1560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35E8-4DF5-9E3A-4B43671A1560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35E8-4DF5-9E3A-4B43671A1560}"/>
              </c:ext>
            </c:extLst>
          </c:dPt>
          <c:dPt>
            <c:idx val="12"/>
            <c:bubble3D val="0"/>
            <c:spPr>
              <a:solidFill>
                <a:schemeClr val="accent1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35E8-4DF5-9E3A-4B43671A1560}"/>
              </c:ext>
            </c:extLst>
          </c:dPt>
          <c:dPt>
            <c:idx val="13"/>
            <c:bubble3D val="0"/>
            <c:spPr>
              <a:solidFill>
                <a:schemeClr val="accent2">
                  <a:lumMod val="80000"/>
                  <a:lumOff val="2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35E8-4DF5-9E3A-4B43671A1560}"/>
              </c:ext>
            </c:extLst>
          </c:dPt>
          <c:dLbls>
            <c:dLbl>
              <c:idx val="1"/>
              <c:layout>
                <c:manualLayout>
                  <c:x val="5.855071222223808E-2"/>
                  <c:y val="-7.5049006111998232E-2"/>
                </c:manualLayout>
              </c:layout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3-35E8-4DF5-9E3A-4B43671A1560}"/>
                </c:ext>
              </c:extLst>
            </c:dLbl>
            <c:dLbl>
              <c:idx val="2"/>
              <c:layout>
                <c:manualLayout>
                  <c:x val="0.11872636945810464"/>
                  <c:y val="0.1602926600958097"/>
                </c:manualLayout>
              </c:layout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35E8-4DF5-9E3A-4B43671A1560}"/>
                </c:ext>
              </c:extLst>
            </c:dLbl>
            <c:dLbl>
              <c:idx val="3"/>
              <c:layout>
                <c:manualLayout>
                  <c:x val="-4.6977228333329934E-3"/>
                  <c:y val="-8.7942844557017785E-2"/>
                </c:manualLayout>
              </c:layout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7-35E8-4DF5-9E3A-4B43671A1560}"/>
                </c:ext>
              </c:extLst>
            </c:dLbl>
            <c:dLbl>
              <c:idx val="4"/>
              <c:layout>
                <c:manualLayout>
                  <c:x val="-1.4100987273077108E-3"/>
                  <c:y val="2.08242938164198E-2"/>
                </c:manualLayout>
              </c:layout>
              <c:tx>
                <c:rich>
                  <a:bodyPr/>
                  <a:lstStyle/>
                  <a:p>
                    <a:fld id="{994C9FB5-75EC-443E-874D-22FDCD1E3E30}" type="CATEGORYNAME">
                      <a:rPr lang="en-US" altLang="zh-CN"/>
                      <a:pPr/>
                      <a:t>[类别名称]</a:t>
                    </a:fld>
                    <a:r>
                      <a:rPr lang="en-US" altLang="zh-CN" baseline="0"/>
                      <a:t>, </a:t>
                    </a:r>
                    <a:fld id="{2FE5E690-50F8-4D36-9412-0B1B15DA9718}" type="VALUE">
                      <a:rPr lang="en-US" altLang="zh-CN" baseline="0"/>
                      <a:pPr/>
                      <a:t>[值]</a:t>
                    </a:fld>
                    <a:r>
                      <a:rPr lang="en-US" altLang="zh-CN" baseline="0"/>
                      <a:t>, 1.8%</a:t>
                    </a:r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9-35E8-4DF5-9E3A-4B43671A1560}"/>
                </c:ext>
              </c:extLst>
            </c:dLbl>
            <c:dLbl>
              <c:idx val="5"/>
              <c:layout>
                <c:manualLayout>
                  <c:x val="-4.8667443104828151E-2"/>
                  <c:y val="-0.11156819558394361"/>
                </c:manualLayout>
              </c:layout>
              <c:tx>
                <c:rich>
                  <a:bodyPr/>
                  <a:lstStyle/>
                  <a:p>
                    <a:fld id="{35C87CF4-7666-481D-B161-31070E720EE2}" type="CATEGORYNAME">
                      <a:rPr lang="en-US" altLang="zh-CN"/>
                      <a:pPr/>
                      <a:t>[类别名称]</a:t>
                    </a:fld>
                    <a:r>
                      <a:rPr lang="en-US" altLang="zh-CN" baseline="0"/>
                      <a:t>, </a:t>
                    </a:r>
                    <a:fld id="{58C24ECD-FBD3-470E-A767-4730B8661E6F}" type="VALUE">
                      <a:rPr lang="en-US" altLang="zh-CN" baseline="0"/>
                      <a:pPr/>
                      <a:t>[值]</a:t>
                    </a:fld>
                    <a:r>
                      <a:rPr lang="en-US" altLang="zh-CN" baseline="0"/>
                      <a:t>, 17.5%</a:t>
                    </a:r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B-35E8-4DF5-9E3A-4B43671A1560}"/>
                </c:ext>
              </c:extLst>
            </c:dLbl>
            <c:dLbl>
              <c:idx val="6"/>
              <c:layout>
                <c:manualLayout>
                  <c:x val="5.5402381258332946E-2"/>
                  <c:y val="7.2092671108419146E-2"/>
                </c:manualLayout>
              </c:layout>
              <c:tx>
                <c:rich>
                  <a:bodyPr/>
                  <a:lstStyle/>
                  <a:p>
                    <a:fld id="{30D986FF-2A55-4C28-BE02-917803500363}" type="CATEGORYNAME">
                      <a:rPr lang="en-US" altLang="zh-CN"/>
                      <a:pPr/>
                      <a:t>[类别名称]</a:t>
                    </a:fld>
                    <a:r>
                      <a:rPr lang="en-US" altLang="zh-CN" baseline="0"/>
                      <a:t>, </a:t>
                    </a:r>
                    <a:fld id="{0DD21827-55F5-4FAF-9AAF-EABFAD3DD3E7}" type="VALUE">
                      <a:rPr lang="en-US" altLang="zh-CN" baseline="0"/>
                      <a:pPr/>
                      <a:t>[值]</a:t>
                    </a:fld>
                    <a:r>
                      <a:rPr lang="en-US" altLang="zh-CN" baseline="0"/>
                      <a:t>, 3.5%</a:t>
                    </a:r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D-35E8-4DF5-9E3A-4B43671A1560}"/>
                </c:ext>
              </c:extLst>
            </c:dLbl>
            <c:dLbl>
              <c:idx val="8"/>
              <c:layout>
                <c:manualLayout>
                  <c:x val="2.0232095179624415E-2"/>
                  <c:y val="1.2132867132867133E-2"/>
                </c:manualLayout>
              </c:layout>
              <c:tx>
                <c:rich>
                  <a:bodyPr/>
                  <a:lstStyle/>
                  <a:p>
                    <a:fld id="{FEDD424B-FA86-42A4-A030-BFB4997CEF4D}" type="CATEGORYNAME">
                      <a:rPr lang="en-US" altLang="zh-CN"/>
                      <a:pPr/>
                      <a:t>[类别名称]</a:t>
                    </a:fld>
                    <a:r>
                      <a:rPr lang="en-US" altLang="zh-CN" baseline="0"/>
                      <a:t>, </a:t>
                    </a:r>
                    <a:fld id="{37CC0544-8BC6-4C21-9670-C63A10860D16}" type="VALUE">
                      <a:rPr lang="en-US" altLang="zh-CN" baseline="0"/>
                      <a:pPr/>
                      <a:t>[值]</a:t>
                    </a:fld>
                    <a:r>
                      <a:rPr lang="en-US" altLang="zh-CN" baseline="0"/>
                      <a:t>, 1.8%</a:t>
                    </a:r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1-35E8-4DF5-9E3A-4B43671A1560}"/>
                </c:ext>
              </c:extLst>
            </c:dLbl>
            <c:dLbl>
              <c:idx val="9"/>
              <c:layout>
                <c:manualLayout>
                  <c:x val="0.11019659794984971"/>
                  <c:y val="-5.0812455261274224E-2"/>
                </c:manualLayout>
              </c:layout>
              <c:tx>
                <c:rich>
                  <a:bodyPr/>
                  <a:lstStyle/>
                  <a:p>
                    <a:fld id="{B4A2841C-FE4D-462C-B753-32F0FB23B873}" type="CATEGORYNAME">
                      <a:rPr lang="en-US" altLang="zh-CN"/>
                      <a:pPr/>
                      <a:t>[类别名称]</a:t>
                    </a:fld>
                    <a:r>
                      <a:rPr lang="en-US" altLang="zh-CN" baseline="0"/>
                      <a:t>, </a:t>
                    </a:r>
                    <a:fld id="{8A629F47-E8B0-4399-A7D9-1C5188BEF478}" type="VALUE">
                      <a:rPr lang="en-US" altLang="zh-CN" baseline="0"/>
                      <a:pPr/>
                      <a:t>[值]</a:t>
                    </a:fld>
                    <a:r>
                      <a:rPr lang="en-US" altLang="zh-CN" baseline="0"/>
                      <a:t>, 21.1%</a:t>
                    </a:r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3-35E8-4DF5-9E3A-4B43671A1560}"/>
                </c:ext>
              </c:extLst>
            </c:dLbl>
            <c:dLbl>
              <c:idx val="10"/>
              <c:layout>
                <c:manualLayout>
                  <c:x val="8.7468614425024419E-2"/>
                  <c:y val="0.16229723032872639"/>
                </c:manualLayout>
              </c:layout>
              <c:tx>
                <c:rich>
                  <a:bodyPr/>
                  <a:lstStyle/>
                  <a:p>
                    <a:fld id="{0ACAB1E7-B40D-4D70-8B10-B7FFF209F212}" type="CATEGORYNAME">
                      <a:rPr lang="en-US" altLang="zh-CN"/>
                      <a:pPr/>
                      <a:t>[类别名称]</a:t>
                    </a:fld>
                    <a:r>
                      <a:rPr lang="en-US" altLang="zh-CN" baseline="0"/>
                      <a:t>, </a:t>
                    </a:r>
                    <a:fld id="{16B3EEAD-C898-403E-8356-05C574E5C542}" type="VALUE">
                      <a:rPr lang="en-US" altLang="zh-CN" baseline="0"/>
                      <a:pPr/>
                      <a:t>[值]</a:t>
                    </a:fld>
                    <a:r>
                      <a:rPr lang="en-US" altLang="zh-CN" baseline="0"/>
                      <a:t>, 33.3%</a:t>
                    </a:r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1861833441096423"/>
                      <c:h val="7.4790209790209811E-2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5-35E8-4DF5-9E3A-4B43671A1560}"/>
                </c:ext>
              </c:extLst>
            </c:dLbl>
            <c:dLbl>
              <c:idx val="11"/>
              <c:layout>
                <c:manualLayout>
                  <c:x val="-8.6749287301838181E-3"/>
                  <c:y val="1.2825560266505212E-2"/>
                </c:manualLayout>
              </c:layout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7-35E8-4DF5-9E3A-4B43671A1560}"/>
                </c:ext>
              </c:extLst>
            </c:dLbl>
            <c:dLbl>
              <c:idx val="12"/>
              <c:layout/>
              <c:tx>
                <c:rich>
                  <a:bodyPr/>
                  <a:lstStyle/>
                  <a:p>
                    <a:r>
                      <a:rPr lang="en-US" altLang="zh-CN" baseline="0"/>
                      <a:t>Compound atypical, </a:t>
                    </a:r>
                    <a:fld id="{9556D139-A7C6-488E-9DF8-85E995761D39}" type="VALUE">
                      <a:rPr lang="en-US" altLang="zh-CN" baseline="0"/>
                      <a:pPr/>
                      <a:t>[值]</a:t>
                    </a:fld>
                    <a:r>
                      <a:rPr lang="en-US" altLang="zh-CN" baseline="0"/>
                      <a:t>, 21.1%</a:t>
                    </a:r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9-35E8-4DF5-9E3A-4B43671A1560}"/>
                </c:ext>
              </c:extLst>
            </c:dLbl>
            <c:dLbl>
              <c:idx val="13"/>
              <c:layout/>
              <c:tx>
                <c:rich>
                  <a:bodyPr/>
                  <a:lstStyle/>
                  <a:p>
                    <a:r>
                      <a:rPr lang="en-US" altLang="zh-CN" baseline="0"/>
                      <a:t>Atypical, </a:t>
                    </a:r>
                    <a:fld id="{477C33FE-8227-48E9-B828-C5B0391C5896}" type="VALUE">
                      <a:rPr lang="en-US" altLang="zh-CN" baseline="0"/>
                      <a:pPr/>
                      <a:t>[值]</a:t>
                    </a:fld>
                    <a:r>
                      <a:rPr lang="en-US" altLang="zh-CN" baseline="0"/>
                      <a:t>, </a:t>
                    </a:r>
                    <a:fld id="{4CEE78E9-6533-405B-AD6F-A98C1CBC826D}" type="PERCENTAGE">
                      <a:rPr lang="en-US" altLang="zh-CN" baseline="0"/>
                      <a:pPr/>
                      <a:t>[百分比]</a:t>
                    </a:fld>
                    <a:endParaRPr lang="en-US" altLang="zh-CN" baseline="0"/>
                  </a:p>
                </c:rich>
              </c:tx>
              <c:dLblPos val="bestFit"/>
              <c:showLegendKey val="0"/>
              <c:showVal val="1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/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1B-35E8-4DF5-9E3A-4B43671A1560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zh-CN"/>
              </a:p>
            </c:txPr>
            <c:dLblPos val="bestFit"/>
            <c:showLegendKey val="0"/>
            <c:showVal val="1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Later!$A$2:$A$14</c:f>
              <c:strCache>
                <c:ptCount val="13"/>
                <c:pt idx="0">
                  <c:v>Ex19del</c:v>
                </c:pt>
                <c:pt idx="1">
                  <c:v>L858R</c:v>
                </c:pt>
                <c:pt idx="2">
                  <c:v>Ex19del/L858R+T790M</c:v>
                </c:pt>
                <c:pt idx="3">
                  <c:v>T790M</c:v>
                </c:pt>
                <c:pt idx="4">
                  <c:v>Ex20ins</c:v>
                </c:pt>
                <c:pt idx="5">
                  <c:v>L861Q</c:v>
                </c:pt>
                <c:pt idx="6">
                  <c:v>G719X</c:v>
                </c:pt>
                <c:pt idx="7">
                  <c:v>S768X</c:v>
                </c:pt>
                <c:pt idx="8">
                  <c:v>G724S</c:v>
                </c:pt>
                <c:pt idx="9">
                  <c:v>Ex19del/L858R+T790M+atypical </c:v>
                </c:pt>
                <c:pt idx="10">
                  <c:v>Ex19del/L858R+atypical </c:v>
                </c:pt>
                <c:pt idx="11">
                  <c:v>T790M+atypical </c:v>
                </c:pt>
                <c:pt idx="12">
                  <c:v>Compound atypical</c:v>
                </c:pt>
              </c:strCache>
            </c:strRef>
          </c:cat>
          <c:val>
            <c:numRef>
              <c:f>Later!$B$2:$B$14</c:f>
              <c:numCache>
                <c:formatCode>General</c:formatCode>
                <c:ptCount val="13"/>
                <c:pt idx="0">
                  <c:v>55</c:v>
                </c:pt>
                <c:pt idx="1">
                  <c:v>45</c:v>
                </c:pt>
                <c:pt idx="2">
                  <c:v>105</c:v>
                </c:pt>
                <c:pt idx="3">
                  <c:v>1</c:v>
                </c:pt>
                <c:pt idx="4">
                  <c:v>1</c:v>
                </c:pt>
                <c:pt idx="5">
                  <c:v>10</c:v>
                </c:pt>
                <c:pt idx="6">
                  <c:v>2</c:v>
                </c:pt>
                <c:pt idx="8">
                  <c:v>1</c:v>
                </c:pt>
                <c:pt idx="9">
                  <c:v>12</c:v>
                </c:pt>
                <c:pt idx="10">
                  <c:v>19</c:v>
                </c:pt>
                <c:pt idx="12">
                  <c:v>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C-35E8-4DF5-9E3A-4B43671A1560}"/>
            </c:ext>
          </c:extLst>
        </c:ser>
        <c:dLbls>
          <c:dLblPos val="bestFit"/>
          <c:showLegendKey val="0"/>
          <c:showVal val="1"/>
          <c:showCatName val="1"/>
          <c:showSerName val="0"/>
          <c:showPercent val="0"/>
          <c:showBubbleSize val="0"/>
          <c:showLeaderLines val="1"/>
        </c:dLbls>
        <c:gapWidth val="100"/>
        <c:splitType val="pos"/>
        <c:splitPos val="9"/>
        <c:secondPieSize val="100"/>
        <c:serLines>
          <c:spPr>
            <a:ln w="9525" cap="flat" cmpd="sng" algn="ctr">
              <a:solidFill>
                <a:schemeClr val="tx1">
                  <a:lumMod val="35000"/>
                  <a:lumOff val="65000"/>
                </a:schemeClr>
              </a:solidFill>
              <a:round/>
            </a:ln>
            <a:effectLst/>
          </c:spPr>
        </c:serLines>
      </c:of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50000"/>
            <a:lumOff val="50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19050">
        <a:solidFill>
          <a:schemeClr val="lt1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1905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4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50000"/>
            <a:lumOff val="50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19050">
        <a:solidFill>
          <a:schemeClr val="lt1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1905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4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50000"/>
            <a:lumOff val="50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19050">
        <a:solidFill>
          <a:schemeClr val="lt1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1905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4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50000"/>
            <a:lumOff val="50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19050">
        <a:solidFill>
          <a:schemeClr val="lt1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1905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4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F26A1-CB98-4BF6-8EDD-15356B20A7C0}" type="datetimeFigureOut">
              <a:rPr lang="zh-CN" altLang="en-US" smtClean="0"/>
              <a:t>2022/12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EA193-2AA2-4C2F-96E7-C4B3844D46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17311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F26A1-CB98-4BF6-8EDD-15356B20A7C0}" type="datetimeFigureOut">
              <a:rPr lang="zh-CN" altLang="en-US" smtClean="0"/>
              <a:t>2022/12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EA193-2AA2-4C2F-96E7-C4B3844D46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59762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F26A1-CB98-4BF6-8EDD-15356B20A7C0}" type="datetimeFigureOut">
              <a:rPr lang="zh-CN" altLang="en-US" smtClean="0"/>
              <a:t>2022/12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EA193-2AA2-4C2F-96E7-C4B3844D46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69021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F26A1-CB98-4BF6-8EDD-15356B20A7C0}" type="datetimeFigureOut">
              <a:rPr lang="zh-CN" altLang="en-US" smtClean="0"/>
              <a:t>2022/12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EA193-2AA2-4C2F-96E7-C4B3844D46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40406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F26A1-CB98-4BF6-8EDD-15356B20A7C0}" type="datetimeFigureOut">
              <a:rPr lang="zh-CN" altLang="en-US" smtClean="0"/>
              <a:t>2022/12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EA193-2AA2-4C2F-96E7-C4B3844D46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1914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F26A1-CB98-4BF6-8EDD-15356B20A7C0}" type="datetimeFigureOut">
              <a:rPr lang="zh-CN" altLang="en-US" smtClean="0"/>
              <a:t>2022/12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EA193-2AA2-4C2F-96E7-C4B3844D46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9382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F26A1-CB98-4BF6-8EDD-15356B20A7C0}" type="datetimeFigureOut">
              <a:rPr lang="zh-CN" altLang="en-US" smtClean="0"/>
              <a:t>2022/12/2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EA193-2AA2-4C2F-96E7-C4B3844D46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31824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F26A1-CB98-4BF6-8EDD-15356B20A7C0}" type="datetimeFigureOut">
              <a:rPr lang="zh-CN" altLang="en-US" smtClean="0"/>
              <a:t>2022/12/2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EA193-2AA2-4C2F-96E7-C4B3844D46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8296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F26A1-CB98-4BF6-8EDD-15356B20A7C0}" type="datetimeFigureOut">
              <a:rPr lang="zh-CN" altLang="en-US" smtClean="0"/>
              <a:t>2022/12/2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EA193-2AA2-4C2F-96E7-C4B3844D46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5949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F26A1-CB98-4BF6-8EDD-15356B20A7C0}" type="datetimeFigureOut">
              <a:rPr lang="zh-CN" altLang="en-US" smtClean="0"/>
              <a:t>2022/12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EA193-2AA2-4C2F-96E7-C4B3844D46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5877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5F26A1-CB98-4BF6-8EDD-15356B20A7C0}" type="datetimeFigureOut">
              <a:rPr lang="zh-CN" altLang="en-US" smtClean="0"/>
              <a:t>2022/12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CEA193-2AA2-4C2F-96E7-C4B3844D46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22837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5F26A1-CB98-4BF6-8EDD-15356B20A7C0}" type="datetimeFigureOut">
              <a:rPr lang="zh-CN" altLang="en-US" smtClean="0"/>
              <a:t>2022/12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CEA193-2AA2-4C2F-96E7-C4B3844D461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6779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图表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2164166"/>
              </p:ext>
            </p:extLst>
          </p:nvPr>
        </p:nvGraphicFramePr>
        <p:xfrm>
          <a:off x="307179" y="4430713"/>
          <a:ext cx="5711825" cy="3244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文本框 4"/>
          <p:cNvSpPr txBox="1"/>
          <p:nvPr/>
        </p:nvSpPr>
        <p:spPr>
          <a:xfrm>
            <a:off x="214311" y="473076"/>
            <a:ext cx="6000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214311" y="5091112"/>
            <a:ext cx="6000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307181" y="8088996"/>
            <a:ext cx="655082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. 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Distribution of classical and atypical EGFR mutations in TKI treatment naïve patients (A) and those developing PD to TKI (B).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1607676" y="3581327"/>
            <a:ext cx="35218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TKI treatment naïve patients  </a:t>
            </a:r>
            <a:endParaRPr lang="zh-CN" altLang="en-US" b="1" dirty="0"/>
          </a:p>
        </p:txBody>
      </p:sp>
      <p:sp>
        <p:nvSpPr>
          <p:cNvPr id="10" name="文本框 9"/>
          <p:cNvSpPr txBox="1"/>
          <p:nvPr/>
        </p:nvSpPr>
        <p:spPr>
          <a:xfrm>
            <a:off x="2062163" y="7490897"/>
            <a:ext cx="27574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Re- Biopsied at PD to </a:t>
            </a:r>
            <a:r>
              <a:rPr lang="en-US" altLang="zh-CN" b="1" dirty="0"/>
              <a:t>TKI</a:t>
            </a:r>
            <a:endParaRPr lang="zh-CN" altLang="en-US" b="1" dirty="0"/>
          </a:p>
        </p:txBody>
      </p:sp>
      <p:graphicFrame>
        <p:nvGraphicFramePr>
          <p:cNvPr id="16" name="图表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6016733"/>
              </p:ext>
            </p:extLst>
          </p:nvPr>
        </p:nvGraphicFramePr>
        <p:xfrm>
          <a:off x="482409" y="3875986"/>
          <a:ext cx="5883276" cy="3632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图表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05804479"/>
              </p:ext>
            </p:extLst>
          </p:nvPr>
        </p:nvGraphicFramePr>
        <p:xfrm>
          <a:off x="221453" y="684130"/>
          <a:ext cx="5883276" cy="3632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3" name="图表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60242640"/>
              </p:ext>
            </p:extLst>
          </p:nvPr>
        </p:nvGraphicFramePr>
        <p:xfrm>
          <a:off x="499268" y="3875986"/>
          <a:ext cx="5883276" cy="3632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4322298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200026" y="7606010"/>
            <a:ext cx="641508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. 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Comparison of TTF in patients with Ex20ins-L </a:t>
            </a:r>
            <a:r>
              <a:rPr lang="en-US" altLang="zh-CN" i="1" dirty="0" smtClean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mutation upon different therapies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9468" y="542535"/>
            <a:ext cx="3124200" cy="305943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87104" y="542535"/>
            <a:ext cx="3128010" cy="307848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0602" y="4173495"/>
            <a:ext cx="3116580" cy="311658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83688" y="4181115"/>
            <a:ext cx="3108960" cy="3101340"/>
          </a:xfrm>
          <a:prstGeom prst="rect">
            <a:avLst/>
          </a:prstGeom>
        </p:spPr>
      </p:pic>
      <p:sp>
        <p:nvSpPr>
          <p:cNvPr id="8" name="文本框 7"/>
          <p:cNvSpPr txBox="1"/>
          <p:nvPr/>
        </p:nvSpPr>
        <p:spPr>
          <a:xfrm>
            <a:off x="1563624" y="203981"/>
            <a:ext cx="15544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altLang="zh-CN" sz="16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altLang="zh-CN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line 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4724210" y="203981"/>
            <a:ext cx="15544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ll lines 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13727" y="353324"/>
            <a:ext cx="293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3502534" y="268496"/>
            <a:ext cx="293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113727" y="3857560"/>
            <a:ext cx="293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612644" y="3888927"/>
            <a:ext cx="293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18342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2"/>
          <p:cNvSpPr/>
          <p:nvPr/>
        </p:nvSpPr>
        <p:spPr>
          <a:xfrm>
            <a:off x="157161" y="8584047"/>
            <a:ext cx="6500813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.  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Comparison of TTF in patients with T790M-like </a:t>
            </a:r>
            <a:r>
              <a:rPr lang="en-US" altLang="zh-CN" i="1" dirty="0" smtClean="0">
                <a:latin typeface="Arial" panose="020B0604020202020204" pitchFamily="34" charset="0"/>
                <a:cs typeface="Arial" panose="020B0604020202020204" pitchFamily="34" charset="0"/>
              </a:rPr>
              <a:t>EGFR</a:t>
            </a:r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 mutation upon different therapies. A-B  All T790M-like mutations; C. atypical, T790M-like mutations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1938" y="1737953"/>
            <a:ext cx="3135630" cy="3074670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22345" y="1737953"/>
            <a:ext cx="3135630" cy="312420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39753" y="5181955"/>
            <a:ext cx="3147060" cy="308229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347472" y="1426464"/>
            <a:ext cx="384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3522345" y="1368621"/>
            <a:ext cx="384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964817" y="4812623"/>
            <a:ext cx="384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42636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CAEACE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25</TotalTime>
  <Words>213</Words>
  <Application>Microsoft Office PowerPoint</Application>
  <PresentationFormat>A4 纸张(210x297 毫米)</PresentationFormat>
  <Paragraphs>37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邵林-数据科学部</dc:creator>
  <cp:lastModifiedBy>邵林-数据科学部</cp:lastModifiedBy>
  <cp:revision>21</cp:revision>
  <dcterms:created xsi:type="dcterms:W3CDTF">2022-10-19T08:37:01Z</dcterms:created>
  <dcterms:modified xsi:type="dcterms:W3CDTF">2022-12-28T04:19:40Z</dcterms:modified>
</cp:coreProperties>
</file>